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8B4B9A6-141D-C907-01B7-E1C1C8D52B6B}" v="4" dt="2025-12-23T01:21:55.62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62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辰巳　めぐみ" userId="S::megumi_tatsumi@ncnp.go.jp::88b1893c-db63-4bb5-9dca-a6ce3447aab8" providerId="AD" clId="Web-{68B4B9A6-141D-C907-01B7-E1C1C8D52B6B}"/>
    <pc:docChg chg="modSld">
      <pc:chgData name="辰巳　めぐみ" userId="S::megumi_tatsumi@ncnp.go.jp::88b1893c-db63-4bb5-9dca-a6ce3447aab8" providerId="AD" clId="Web-{68B4B9A6-141D-C907-01B7-E1C1C8D52B6B}" dt="2025-12-23T01:21:55.628" v="2"/>
      <pc:docMkLst>
        <pc:docMk/>
      </pc:docMkLst>
      <pc:sldChg chg="delSp modSp">
        <pc:chgData name="辰巳　めぐみ" userId="S::megumi_tatsumi@ncnp.go.jp::88b1893c-db63-4bb5-9dca-a6ce3447aab8" providerId="AD" clId="Web-{68B4B9A6-141D-C907-01B7-E1C1C8D52B6B}" dt="2025-12-23T01:21:55.628" v="2"/>
        <pc:sldMkLst>
          <pc:docMk/>
          <pc:sldMk cId="3285713202" sldId="256"/>
        </pc:sldMkLst>
        <pc:spChg chg="del mod">
          <ac:chgData name="辰巳　めぐみ" userId="S::megumi_tatsumi@ncnp.go.jp::88b1893c-db63-4bb5-9dca-a6ce3447aab8" providerId="AD" clId="Web-{68B4B9A6-141D-C907-01B7-E1C1C8D52B6B}" dt="2025-12-23T01:21:55.628" v="2"/>
          <ac:spMkLst>
            <pc:docMk/>
            <pc:sldMk cId="3285713202" sldId="256"/>
            <ac:spMk id="6" creationId="{783F891D-0647-14CC-9AD9-CD53062CAF9A}"/>
          </ac:spMkLst>
        </pc:spChg>
      </pc:sldChg>
    </pc:docChg>
  </pc:docChgLst>
  <pc:docChgLst>
    <pc:chgData name="辰巳　めぐみ" userId="88b1893c-db63-4bb5-9dca-a6ce3447aab8" providerId="ADAL" clId="{4C98BF49-9253-44F8-8335-0E5DA0562794}"/>
    <pc:docChg chg="undo custSel modSld">
      <pc:chgData name="辰巳　めぐみ" userId="88b1893c-db63-4bb5-9dca-a6ce3447aab8" providerId="ADAL" clId="{4C98BF49-9253-44F8-8335-0E5DA0562794}" dt="2025-12-16T07:17:16.010" v="129" actId="1076"/>
      <pc:docMkLst>
        <pc:docMk/>
      </pc:docMkLst>
      <pc:sldChg chg="addSp delSp modSp mod">
        <pc:chgData name="辰巳　めぐみ" userId="88b1893c-db63-4bb5-9dca-a6ce3447aab8" providerId="ADAL" clId="{4C98BF49-9253-44F8-8335-0E5DA0562794}" dt="2025-12-16T07:17:16.010" v="129" actId="1076"/>
        <pc:sldMkLst>
          <pc:docMk/>
          <pc:sldMk cId="3285713202" sldId="256"/>
        </pc:sldMkLst>
        <pc:spChg chg="mod">
          <ac:chgData name="辰巳　めぐみ" userId="88b1893c-db63-4bb5-9dca-a6ce3447aab8" providerId="ADAL" clId="{4C98BF49-9253-44F8-8335-0E5DA0562794}" dt="2025-12-16T05:35:45.993" v="31"/>
          <ac:spMkLst>
            <pc:docMk/>
            <pc:sldMk cId="3285713202" sldId="256"/>
            <ac:spMk id="5" creationId="{131A1956-03FD-E9AD-3AD1-02E5585409FB}"/>
          </ac:spMkLst>
        </pc:spChg>
        <pc:spChg chg="add mod">
          <ac:chgData name="辰巳　めぐみ" userId="88b1893c-db63-4bb5-9dca-a6ce3447aab8" providerId="ADAL" clId="{4C98BF49-9253-44F8-8335-0E5DA0562794}" dt="2025-12-16T05:37:25.763" v="59" actId="1076"/>
          <ac:spMkLst>
            <pc:docMk/>
            <pc:sldMk cId="3285713202" sldId="256"/>
            <ac:spMk id="6" creationId="{783F891D-0647-14CC-9AD9-CD53062CAF9A}"/>
          </ac:spMkLst>
        </pc:spChg>
        <pc:spChg chg="add mod">
          <ac:chgData name="辰巳　めぐみ" userId="88b1893c-db63-4bb5-9dca-a6ce3447aab8" providerId="ADAL" clId="{4C98BF49-9253-44F8-8335-0E5DA0562794}" dt="2025-12-16T07:04:33.492" v="67" actId="1076"/>
          <ac:spMkLst>
            <pc:docMk/>
            <pc:sldMk cId="3285713202" sldId="256"/>
            <ac:spMk id="7" creationId="{C05F8CE9-3B9F-C409-DA1F-59F505D70D1A}"/>
          </ac:spMkLst>
        </pc:spChg>
        <pc:spChg chg="add mod">
          <ac:chgData name="辰巳　めぐみ" userId="88b1893c-db63-4bb5-9dca-a6ce3447aab8" providerId="ADAL" clId="{4C98BF49-9253-44F8-8335-0E5DA0562794}" dt="2025-12-16T07:04:43.640" v="70" actId="20577"/>
          <ac:spMkLst>
            <pc:docMk/>
            <pc:sldMk cId="3285713202" sldId="256"/>
            <ac:spMk id="8" creationId="{B9D759A7-349B-3570-02EB-C9B4D5061513}"/>
          </ac:spMkLst>
        </pc:spChg>
        <pc:spChg chg="add mod">
          <ac:chgData name="辰巳　めぐみ" userId="88b1893c-db63-4bb5-9dca-a6ce3447aab8" providerId="ADAL" clId="{4C98BF49-9253-44F8-8335-0E5DA0562794}" dt="2025-12-16T07:04:57.478" v="75" actId="20577"/>
          <ac:spMkLst>
            <pc:docMk/>
            <pc:sldMk cId="3285713202" sldId="256"/>
            <ac:spMk id="9" creationId="{7B354D85-517D-D3C1-FCF5-9B02BC17D39A}"/>
          </ac:spMkLst>
        </pc:spChg>
        <pc:spChg chg="add mod">
          <ac:chgData name="辰巳　めぐみ" userId="88b1893c-db63-4bb5-9dca-a6ce3447aab8" providerId="ADAL" clId="{4C98BF49-9253-44F8-8335-0E5DA0562794}" dt="2025-12-16T07:15:46.786" v="106" actId="1076"/>
          <ac:spMkLst>
            <pc:docMk/>
            <pc:sldMk cId="3285713202" sldId="256"/>
            <ac:spMk id="10" creationId="{1116DCB3-A2AD-A09A-4595-CE06BA57E539}"/>
          </ac:spMkLst>
        </pc:spChg>
        <pc:spChg chg="add mod">
          <ac:chgData name="辰巳　めぐみ" userId="88b1893c-db63-4bb5-9dca-a6ce3447aab8" providerId="ADAL" clId="{4C98BF49-9253-44F8-8335-0E5DA0562794}" dt="2025-12-16T07:15:58.017" v="108" actId="1076"/>
          <ac:spMkLst>
            <pc:docMk/>
            <pc:sldMk cId="3285713202" sldId="256"/>
            <ac:spMk id="11" creationId="{400F2061-9B45-C117-BFD5-E4AE135DB06E}"/>
          </ac:spMkLst>
        </pc:spChg>
        <pc:spChg chg="add mod">
          <ac:chgData name="辰巳　めぐみ" userId="88b1893c-db63-4bb5-9dca-a6ce3447aab8" providerId="ADAL" clId="{4C98BF49-9253-44F8-8335-0E5DA0562794}" dt="2025-12-16T07:16:15.388" v="110" actId="1076"/>
          <ac:spMkLst>
            <pc:docMk/>
            <pc:sldMk cId="3285713202" sldId="256"/>
            <ac:spMk id="12" creationId="{AF4EA7ED-9104-8439-0F87-046962DE1528}"/>
          </ac:spMkLst>
        </pc:spChg>
        <pc:spChg chg="add mod">
          <ac:chgData name="辰巳　めぐみ" userId="88b1893c-db63-4bb5-9dca-a6ce3447aab8" providerId="ADAL" clId="{4C98BF49-9253-44F8-8335-0E5DA0562794}" dt="2025-12-16T07:16:53.622" v="125" actId="1076"/>
          <ac:spMkLst>
            <pc:docMk/>
            <pc:sldMk cId="3285713202" sldId="256"/>
            <ac:spMk id="13" creationId="{7B882E9F-BA90-523C-43F1-F9DB670DD33F}"/>
          </ac:spMkLst>
        </pc:spChg>
        <pc:spChg chg="add mod">
          <ac:chgData name="辰巳　めぐみ" userId="88b1893c-db63-4bb5-9dca-a6ce3447aab8" providerId="ADAL" clId="{4C98BF49-9253-44F8-8335-0E5DA0562794}" dt="2025-12-16T07:17:07.475" v="127" actId="1076"/>
          <ac:spMkLst>
            <pc:docMk/>
            <pc:sldMk cId="3285713202" sldId="256"/>
            <ac:spMk id="14" creationId="{9B6962F4-D209-6D69-5234-0FB4B3446360}"/>
          </ac:spMkLst>
        </pc:spChg>
        <pc:spChg chg="add mod">
          <ac:chgData name="辰巳　めぐみ" userId="88b1893c-db63-4bb5-9dca-a6ce3447aab8" providerId="ADAL" clId="{4C98BF49-9253-44F8-8335-0E5DA0562794}" dt="2025-12-16T07:17:16.010" v="129" actId="1076"/>
          <ac:spMkLst>
            <pc:docMk/>
            <pc:sldMk cId="3285713202" sldId="256"/>
            <ac:spMk id="15" creationId="{4487B602-B386-BEA6-D389-A67378E4F19D}"/>
          </ac:spMkLst>
        </pc:spChg>
        <pc:picChg chg="add mod">
          <ac:chgData name="辰巳　めぐみ" userId="88b1893c-db63-4bb5-9dca-a6ce3447aab8" providerId="ADAL" clId="{4C98BF49-9253-44F8-8335-0E5DA0562794}" dt="2025-12-16T07:04:19.732" v="62" actId="1076"/>
          <ac:picMkLst>
            <pc:docMk/>
            <pc:sldMk cId="3285713202" sldId="256"/>
            <ac:picMk id="2" creationId="{D4D3FAC0-499B-2E6B-A521-45BE18468F56}"/>
          </ac:picMkLst>
        </pc:picChg>
        <pc:picChg chg="add mod">
          <ac:chgData name="辰巳　めぐみ" userId="88b1893c-db63-4bb5-9dca-a6ce3447aab8" providerId="ADAL" clId="{4C98BF49-9253-44F8-8335-0E5DA0562794}" dt="2025-12-16T07:04:50.045" v="73" actId="1076"/>
          <ac:picMkLst>
            <pc:docMk/>
            <pc:sldMk cId="3285713202" sldId="256"/>
            <ac:picMk id="3" creationId="{4E4CAC08-DBBD-E923-BEEA-84314BB2E378}"/>
          </ac:picMkLst>
        </pc:picChg>
        <pc:picChg chg="add mod">
          <ac:chgData name="辰巳　めぐみ" userId="88b1893c-db63-4bb5-9dca-a6ce3447aab8" providerId="ADAL" clId="{4C98BF49-9253-44F8-8335-0E5DA0562794}" dt="2025-12-16T07:04:24.716" v="64" actId="1076"/>
          <ac:picMkLst>
            <pc:docMk/>
            <pc:sldMk cId="3285713202" sldId="256"/>
            <ac:picMk id="4" creationId="{192FA4FA-F585-30EB-31D1-CB5433C22F38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5/12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483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5/12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0222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5/12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6442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5/12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18247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5/12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265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5/12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9631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5/12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4926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5/12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0250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5/12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1329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5/12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1985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5/12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5620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DEEEC0-1DA5-433C-AB0C-50E654322AAD}" type="datetimeFigureOut">
              <a:rPr kumimoji="1" lang="ja-JP" altLang="en-US" smtClean="0"/>
              <a:t>2025/12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9979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31A1956-03FD-E9AD-3AD1-02E5585409FB}"/>
              </a:ext>
            </a:extLst>
          </p:cNvPr>
          <p:cNvSpPr txBox="1"/>
          <p:nvPr/>
        </p:nvSpPr>
        <p:spPr>
          <a:xfrm>
            <a:off x="1144945" y="4606048"/>
            <a:ext cx="6854109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1000"/>
              </a:spcAft>
            </a:pPr>
            <a:r>
              <a:rPr lang="en-US" altLang="ja-JP" sz="1400" b="1" dirty="0">
                <a:effectLst/>
                <a:latin typeface="Times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2.</a:t>
            </a:r>
            <a:r>
              <a:rPr lang="en-US" altLang="ja-JP" sz="1400" dirty="0">
                <a:effectLst/>
                <a:latin typeface="Times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effectLst/>
                <a:latin typeface="Times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mpact of blood contamination on the CSF proteome analyzed by volcano plots.</a:t>
            </a:r>
            <a:endParaRPr lang="ja-JP" altLang="ja-JP" sz="1400" dirty="0">
              <a:effectLst/>
              <a:latin typeface="Times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D4D3FAC0-499B-2E6B-A521-45BE18468F56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475723" y="1253212"/>
            <a:ext cx="2628000" cy="262800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4E4CAC08-DBBD-E923-BEEA-84314BB2E378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60656" y="1253212"/>
            <a:ext cx="2628000" cy="262800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192FA4FA-F585-30EB-31D1-CB5433C22F38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6040279" y="1253212"/>
            <a:ext cx="2628000" cy="262800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05F8CE9-3B9F-C409-DA1F-59F505D70D1A}"/>
              </a:ext>
            </a:extLst>
          </p:cNvPr>
          <p:cNvSpPr txBox="1"/>
          <p:nvPr/>
        </p:nvSpPr>
        <p:spPr>
          <a:xfrm>
            <a:off x="485549" y="103614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9D759A7-349B-3570-02EB-C9B4D5061513}"/>
              </a:ext>
            </a:extLst>
          </p:cNvPr>
          <p:cNvSpPr txBox="1"/>
          <p:nvPr/>
        </p:nvSpPr>
        <p:spPr>
          <a:xfrm>
            <a:off x="3255346" y="1033380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B354D85-517D-D3C1-FCF5-9B02BC17D39A}"/>
              </a:ext>
            </a:extLst>
          </p:cNvPr>
          <p:cNvSpPr txBox="1"/>
          <p:nvPr/>
        </p:nvSpPr>
        <p:spPr>
          <a:xfrm>
            <a:off x="6025143" y="103337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116DCB3-A2AD-A09A-4595-CE06BA57E539}"/>
              </a:ext>
            </a:extLst>
          </p:cNvPr>
          <p:cNvSpPr txBox="1"/>
          <p:nvPr/>
        </p:nvSpPr>
        <p:spPr>
          <a:xfrm>
            <a:off x="1189131" y="3828131"/>
            <a:ext cx="13324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00F2061-9B45-C117-BFD5-E4AE135DB06E}"/>
              </a:ext>
            </a:extLst>
          </p:cNvPr>
          <p:cNvSpPr txBox="1"/>
          <p:nvPr/>
        </p:nvSpPr>
        <p:spPr>
          <a:xfrm>
            <a:off x="3965844" y="3828131"/>
            <a:ext cx="13324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F4EA7ED-9104-8439-0F87-046962DE1528}"/>
              </a:ext>
            </a:extLst>
          </p:cNvPr>
          <p:cNvSpPr txBox="1"/>
          <p:nvPr/>
        </p:nvSpPr>
        <p:spPr>
          <a:xfrm>
            <a:off x="6742557" y="3824046"/>
            <a:ext cx="13324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B882E9F-BA90-523C-43F1-F9DB670DD33F}"/>
              </a:ext>
            </a:extLst>
          </p:cNvPr>
          <p:cNvSpPr txBox="1"/>
          <p:nvPr/>
        </p:nvSpPr>
        <p:spPr>
          <a:xfrm rot="16200000">
            <a:off x="-178382" y="2368361"/>
            <a:ext cx="11512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B6962F4-D209-6D69-5234-0FB4B3446360}"/>
              </a:ext>
            </a:extLst>
          </p:cNvPr>
          <p:cNvSpPr txBox="1"/>
          <p:nvPr/>
        </p:nvSpPr>
        <p:spPr>
          <a:xfrm rot="16200000">
            <a:off x="2606551" y="2368361"/>
            <a:ext cx="11512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487B602-B386-BEA6-D389-A67378E4F19D}"/>
              </a:ext>
            </a:extLst>
          </p:cNvPr>
          <p:cNvSpPr txBox="1"/>
          <p:nvPr/>
        </p:nvSpPr>
        <p:spPr>
          <a:xfrm rot="16200000">
            <a:off x="5420455" y="2368361"/>
            <a:ext cx="11512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5713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09e658bc-5f5e-48b2-a593-8f2a4dff4e86">
      <Terms xmlns="http://schemas.microsoft.com/office/infopath/2007/PartnerControls"/>
    </lcf76f155ced4ddcb4097134ff3c332f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34E485A41FBE0840AEF03DC6126CF7E9" ma:contentTypeVersion="10" ma:contentTypeDescription="新しいドキュメントを作成します。" ma:contentTypeScope="" ma:versionID="b7fc72b48302197a3c00e12c5a71d0f2">
  <xsd:schema xmlns:xsd="http://www.w3.org/2001/XMLSchema" xmlns:xs="http://www.w3.org/2001/XMLSchema" xmlns:p="http://schemas.microsoft.com/office/2006/metadata/properties" xmlns:ns2="09e658bc-5f5e-48b2-a593-8f2a4dff4e86" targetNamespace="http://schemas.microsoft.com/office/2006/metadata/properties" ma:root="true" ma:fieldsID="3811df9a92dabbc9fbde200746e96434" ns2:_="">
    <xsd:import namespace="09e658bc-5f5e-48b2-a593-8f2a4dff4e8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lcf76f155ced4ddcb4097134ff3c332f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ObjectDetectorVersions" minOccurs="0"/>
                <xsd:element ref="ns2:MediaServiceSearchProperties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9e658bc-5f5e-48b2-a593-8f2a4dff4e8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1" nillable="true" ma:taxonomy="true" ma:internalName="lcf76f155ced4ddcb4097134ff3c332f" ma:taxonomyFieldName="MediaServiceImageTags" ma:displayName="画像タグ" ma:readOnly="false" ma:fieldId="{5cf76f15-5ced-4ddc-b409-7134ff3c332f}" ma:taxonomyMulti="true" ma:sspId="559d5a2e-65d4-4456-94da-aa20a3af47a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6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17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1F18290B-53BE-4363-9B63-06F5D2615724}">
  <ds:schemaRefs>
    <ds:schemaRef ds:uri="http://schemas.microsoft.com/office/2006/metadata/properties"/>
    <ds:schemaRef ds:uri="http://schemas.microsoft.com/office/infopath/2007/PartnerControls"/>
    <ds:schemaRef ds:uri="09e658bc-5f5e-48b2-a593-8f2a4dff4e86"/>
  </ds:schemaRefs>
</ds:datastoreItem>
</file>

<file path=customXml/itemProps2.xml><?xml version="1.0" encoding="utf-8"?>
<ds:datastoreItem xmlns:ds="http://schemas.openxmlformats.org/officeDocument/2006/customXml" ds:itemID="{3C235C6E-1404-4B81-8473-A52C7CC7065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E25ED94-B3B8-4F91-9AB1-94E182824B56}"/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8</TotalTime>
  <Words>178</Words>
  <Application>Microsoft Office PowerPoint</Application>
  <PresentationFormat>画面に合わせる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辰巳　めぐみ</dc:creator>
  <cp:lastModifiedBy>辰巳　めぐみ</cp:lastModifiedBy>
  <cp:revision>6</cp:revision>
  <dcterms:created xsi:type="dcterms:W3CDTF">2025-03-28T03:13:18Z</dcterms:created>
  <dcterms:modified xsi:type="dcterms:W3CDTF">2025-12-23T01:21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4E485A41FBE0840AEF03DC6126CF7E9</vt:lpwstr>
  </property>
  <property fmtid="{D5CDD505-2E9C-101B-9397-08002B2CF9AE}" pid="3" name="MediaServiceImageTags">
    <vt:lpwstr/>
  </property>
</Properties>
</file>